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0238" autoAdjust="0"/>
    <p:restoredTop sz="99861" autoAdjust="0"/>
  </p:normalViewPr>
  <p:slideViewPr>
    <p:cSldViewPr snapToGrid="0" snapToObjects="1">
      <p:cViewPr>
        <p:scale>
          <a:sx n="100" d="100"/>
          <a:sy n="100" d="100"/>
        </p:scale>
        <p:origin x="-72" y="-66"/>
      </p:cViewPr>
      <p:guideLst>
        <p:guide orient="horz" pos="54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E1661-0E2A-5A4E-8372-56F43A40E6AE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2588F1-F3A2-9D40-B848-C8C54D5D02D8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3917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23545317"/>
              </p:ext>
            </p:extLst>
          </p:nvPr>
        </p:nvGraphicFramePr>
        <p:xfrm>
          <a:off x="857251" y="863600"/>
          <a:ext cx="7734299" cy="3185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03932"/>
                <a:gridCol w="929976"/>
                <a:gridCol w="1022974"/>
                <a:gridCol w="1007474"/>
                <a:gridCol w="1115971"/>
                <a:gridCol w="1053972"/>
              </a:tblGrid>
              <a:tr h="341204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Patients</a:t>
                      </a:r>
                      <a:endParaRPr lang="de-DE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ge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(years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BMI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(kg/m</a:t>
                      </a:r>
                      <a:r>
                        <a:rPr lang="de-DE" sz="800" b="1" baseline="30000">
                          <a:effectLst/>
                          <a:latin typeface="Arial"/>
                          <a:ea typeface="Cambria"/>
                          <a:cs typeface="Times New Roman"/>
                        </a:rPr>
                        <a:t>2</a:t>
                      </a: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Hb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(g/dl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latelets                           (x 10</a:t>
                      </a:r>
                      <a:r>
                        <a:rPr lang="de-DE" sz="800" b="1" baseline="30000">
                          <a:effectLst/>
                          <a:latin typeface="Arial"/>
                          <a:ea typeface="Cambria"/>
                          <a:cs typeface="Times New Roman"/>
                        </a:rPr>
                        <a:t>6</a:t>
                      </a: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/l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Leukocytes                        (x 10</a:t>
                      </a:r>
                      <a:r>
                        <a:rPr lang="de-DE" sz="800" b="1" baseline="30000">
                          <a:effectLst/>
                          <a:latin typeface="Arial"/>
                          <a:ea typeface="Cambria"/>
                          <a:cs typeface="Times New Roman"/>
                        </a:rPr>
                        <a:t>6</a:t>
                      </a: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/l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45605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atients with active synovial sarcoma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Individual Cohort (IC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(n=3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47.67 ± 9.207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24.83 ± 0.8324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13.17 ± 0.783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178.7 ± 61.8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5.680 ± 0.8932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2621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Healthy controls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(n=5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51.20 ± 4.893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23.62 ± 1.301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14.98 ± 0.5490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174.0 ± 15.53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5.468 ± 0.4835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2621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atients with synovial sarcoma in remission (n=10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44.70 ± 4.33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25.79 ± 1.474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14.31 ± 0.4668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231.9 ± 23.23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6.421 ± 0.5413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41802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-value of patients with active synovial sarcoma (IC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vs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healthy controls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7191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533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098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9283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8249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21820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-value of patients with active synovial sarcoma  (IC)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vs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8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patients with synovial sarcoma in remission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7561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7394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2578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>
                          <a:effectLst/>
                          <a:latin typeface="Arial"/>
                          <a:ea typeface="Cambria"/>
                          <a:cs typeface="Times New Roman"/>
                        </a:rPr>
                        <a:t>0.3376</a:t>
                      </a:r>
                      <a:endParaRPr lang="de-DE" sz="12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7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0.5174</a:t>
                      </a:r>
                      <a:endParaRPr lang="de-DE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Bildschirmpräsentation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priva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lba Fricke</dc:creator>
  <cp:lastModifiedBy>144888</cp:lastModifiedBy>
  <cp:revision>34</cp:revision>
  <dcterms:created xsi:type="dcterms:W3CDTF">2015-05-24T10:05:58Z</dcterms:created>
  <dcterms:modified xsi:type="dcterms:W3CDTF">2015-06-28T20:05:50Z</dcterms:modified>
</cp:coreProperties>
</file>